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4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9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330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5399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598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8713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7857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1090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5858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8253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3116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462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38FE8-A22B-4DA9-B314-87CDEEFD21B9}" type="datetimeFigureOut">
              <a:rPr lang="ko-KR" altLang="en-US" smtClean="0"/>
              <a:t>2019-10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2C32A-4849-44B1-A033-D0B5840E38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5596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0" y="5859269"/>
            <a:ext cx="9144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spcBef>
                <a:spcPts val="600"/>
              </a:spcBef>
              <a:spcAft>
                <a:spcPts val="1200"/>
              </a:spcAft>
            </a:pPr>
            <a:r>
              <a:rPr lang="en-US" altLang="ko-KR" sz="1400" b="1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Figure S1. 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Physiological responses during the DCY84</a:t>
            </a:r>
            <a:r>
              <a:rPr lang="en-US" altLang="ko-KR" sz="1400" baseline="300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T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 and Si treatment of rice seedlings grown in soil. Rice cultivar </a:t>
            </a:r>
            <a:r>
              <a:rPr lang="en-US" altLang="ko-KR" sz="1400" dirty="0" err="1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chilbo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 (control) seed and DCY84</a:t>
            </a:r>
            <a:r>
              <a:rPr lang="en-US" altLang="ko-KR" sz="1400" baseline="300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T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+Si-treated </a:t>
            </a:r>
            <a:r>
              <a:rPr lang="en-US" altLang="ko-KR" sz="1400" dirty="0" err="1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chilbo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 seeds (A) were germinated for 3 d (B), then grown in plastic pots for four weeks. Leaves and roots of normal plants and DCY84</a:t>
            </a:r>
            <a:r>
              <a:rPr lang="en-US" altLang="ko-KR" sz="1400" baseline="300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T</a:t>
            </a:r>
            <a:r>
              <a:rPr lang="en-US" altLang="ko-KR" sz="1400" dirty="0" smtClean="0">
                <a:solidFill>
                  <a:srgbClr val="000000"/>
                </a:solidFill>
                <a:effectLst/>
                <a:latin typeface="Palatino Linotype"/>
                <a:ea typeface="Times New Roman"/>
                <a:cs typeface="Times New Roman"/>
              </a:rPr>
              <a:t>+Si-treated plants were observed at intervals of one week (C-J). Scale bar = 1 cm (A and B) or 5 cm (C-J); N = 3.</a:t>
            </a:r>
            <a:endParaRPr lang="ko-KR" altLang="ko-KR" sz="1400" dirty="0">
              <a:solidFill>
                <a:srgbClr val="000000"/>
              </a:solidFill>
              <a:effectLst/>
              <a:latin typeface="Palatino Linotype"/>
              <a:ea typeface="Times New Roman"/>
              <a:cs typeface="Times New Roman"/>
            </a:endParaRPr>
          </a:p>
        </p:txBody>
      </p:sp>
      <p:pic>
        <p:nvPicPr>
          <p:cNvPr id="1026" name="Picture 2" descr="G:\내 드라이브\24-1. DCY84 and Silicon\1. IJMS (International Journal of Molecular Sciences) 투고 준비\2019.08.08\Figure 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478" y="135214"/>
            <a:ext cx="9014026" cy="5670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27862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8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</cp:revision>
  <dcterms:created xsi:type="dcterms:W3CDTF">2019-10-01T02:27:02Z</dcterms:created>
  <dcterms:modified xsi:type="dcterms:W3CDTF">2019-10-08T10:24:29Z</dcterms:modified>
</cp:coreProperties>
</file>